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9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D8276A-2767-45B0-A69F-EBBE22F02349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002B03-C3C2-4D6D-AED2-A8FA049585A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19240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10BABE-ACE3-4DE7-98FB-EA297AC89AD6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3C58ED-BC3E-4E92-9A15-155009DEF79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97784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4E32EB-BD80-489E-91CE-CF119994AC18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01D68C-EF69-4E43-98CF-7651196655F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60130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83112-8E9B-41C3-90E7-B7479BDBCC3C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DE15D2-702C-4EA9-BD41-56E591A26CB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12784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36C3E-9048-42FA-B7C4-64B9B7F2525B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B25EC6-728E-400C-9739-103AAA83F9D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37586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5C2677-2273-4870-AA90-22D8F203AB81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875B04-77C5-4DC0-BAF8-52706D3CFFA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84090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21AA0C-F2FE-4EF2-A9F6-DFE8802DD436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FD2F3-9E41-459F-A6B1-1B5786FCB47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5041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ACA74F-0604-4890-9BF7-85191EB136F1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65A6DF-730D-4302-B8BF-7B6C98FEFC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18985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D718F0-5B6F-4DD6-AB0E-0FAED9217EE4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CFDA65-8DBC-4110-9E22-239F95980EF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27905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EEB703-4F11-4732-BC2D-B14EFCD955B4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4AF81C-21A9-4C80-8ADF-D77CC2E4FBD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92130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96BD5F-19B3-47D8-997F-46BCE2C65778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0E787D-D8F4-4741-9E3F-4A46AE54892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31918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  <a:endParaRPr lang="en-GB" alt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  <a:endParaRPr lang="en-GB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77BAD3A-39CA-4E6A-8F0E-A92D7E009962}" type="datetimeFigureOut">
              <a:rPr lang="en-GB"/>
              <a:pPr>
                <a:defRPr/>
              </a:pPr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0267E41C-B8A1-48EC-97A5-71EDC1DD08F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4"/>
          <p:cNvSpPr txBox="1">
            <a:spLocks noChangeArrowheads="1"/>
          </p:cNvSpPr>
          <p:nvPr/>
        </p:nvSpPr>
        <p:spPr bwMode="auto">
          <a:xfrm>
            <a:off x="895424" y="4869160"/>
            <a:ext cx="7416800" cy="646331"/>
          </a:xfrm>
          <a:prstGeom prst="rect">
            <a:avLst/>
          </a:prstGeom>
          <a:solidFill>
            <a:schemeClr val="tx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GB" alt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amination </a:t>
            </a:r>
            <a:r>
              <a:rPr lang="en-GB" altLang="en-US" sz="1200" b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the aortic </a:t>
            </a:r>
            <a:r>
              <a:rPr lang="en-GB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ch by two-dimensional, M-mode and colour Doppler echocardiography. (A)</a:t>
            </a:r>
            <a:r>
              <a:rPr lang="en-GB" altLang="en-US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e-TAC aortic arch. </a:t>
            </a:r>
            <a:r>
              <a:rPr lang="en-GB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altLang="en-US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 arch  at 1 </a:t>
            </a:r>
            <a:r>
              <a:rPr lang="en-GB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 after TAC. TAC, transverse aortic constriction.</a:t>
            </a:r>
          </a:p>
        </p:txBody>
      </p:sp>
      <p:grpSp>
        <p:nvGrpSpPr>
          <p:cNvPr id="2051" name="Group 40"/>
          <p:cNvGrpSpPr>
            <a:grpSpLocks/>
          </p:cNvGrpSpPr>
          <p:nvPr/>
        </p:nvGrpSpPr>
        <p:grpSpPr bwMode="auto">
          <a:xfrm>
            <a:off x="601736" y="751632"/>
            <a:ext cx="7786688" cy="3973512"/>
            <a:chOff x="340" y="709"/>
            <a:chExt cx="4905" cy="2503"/>
          </a:xfrm>
        </p:grpSpPr>
        <p:pic>
          <p:nvPicPr>
            <p:cNvPr id="2052" name="Picture 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2769" t="51437" r="60187" b="7138"/>
            <a:stretch>
              <a:fillRect/>
            </a:stretch>
          </p:blipFill>
          <p:spPr bwMode="auto">
            <a:xfrm>
              <a:off x="340" y="1071"/>
              <a:ext cx="1043" cy="21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3" name="Freeform 25"/>
            <p:cNvSpPr>
              <a:spLocks/>
            </p:cNvSpPr>
            <p:nvPr/>
          </p:nvSpPr>
          <p:spPr bwMode="auto">
            <a:xfrm>
              <a:off x="884" y="1616"/>
              <a:ext cx="91" cy="503"/>
            </a:xfrm>
            <a:custGeom>
              <a:avLst/>
              <a:gdLst>
                <a:gd name="T0" fmla="*/ 4 w 275739"/>
                <a:gd name="T1" fmla="*/ 33 h 1546569"/>
                <a:gd name="T2" fmla="*/ 4 w 275739"/>
                <a:gd name="T3" fmla="*/ 6 h 1546569"/>
                <a:gd name="T4" fmla="*/ 13 w 275739"/>
                <a:gd name="T5" fmla="*/ 4 h 1546569"/>
                <a:gd name="T6" fmla="*/ 22 w 275739"/>
                <a:gd name="T7" fmla="*/ 0 h 1546569"/>
                <a:gd name="T8" fmla="*/ 53 w 275739"/>
                <a:gd name="T9" fmla="*/ 2 h 1546569"/>
                <a:gd name="T10" fmla="*/ 69 w 275739"/>
                <a:gd name="T11" fmla="*/ 6 h 1546569"/>
                <a:gd name="T12" fmla="*/ 78 w 275739"/>
                <a:gd name="T13" fmla="*/ 8 h 1546569"/>
                <a:gd name="T14" fmla="*/ 87 w 275739"/>
                <a:gd name="T15" fmla="*/ 25 h 1546569"/>
                <a:gd name="T16" fmla="*/ 90 w 275739"/>
                <a:gd name="T17" fmla="*/ 31 h 1546569"/>
                <a:gd name="T18" fmla="*/ 87 w 275739"/>
                <a:gd name="T19" fmla="*/ 73 h 1546569"/>
                <a:gd name="T20" fmla="*/ 75 w 275739"/>
                <a:gd name="T21" fmla="*/ 90 h 1546569"/>
                <a:gd name="T22" fmla="*/ 69 w 275739"/>
                <a:gd name="T23" fmla="*/ 105 h 1546569"/>
                <a:gd name="T24" fmla="*/ 66 w 275739"/>
                <a:gd name="T25" fmla="*/ 111 h 1546569"/>
                <a:gd name="T26" fmla="*/ 56 w 275739"/>
                <a:gd name="T27" fmla="*/ 141 h 1546569"/>
                <a:gd name="T28" fmla="*/ 47 w 275739"/>
                <a:gd name="T29" fmla="*/ 158 h 1546569"/>
                <a:gd name="T30" fmla="*/ 44 w 275739"/>
                <a:gd name="T31" fmla="*/ 164 h 1546569"/>
                <a:gd name="T32" fmla="*/ 44 w 275739"/>
                <a:gd name="T33" fmla="*/ 313 h 1546569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75739" h="1546569">
                  <a:moveTo>
                    <a:pt x="11788" y="160829"/>
                  </a:moveTo>
                  <a:cubicBezTo>
                    <a:pt x="2246" y="113114"/>
                    <a:pt x="-9110" y="81099"/>
                    <a:pt x="11788" y="28853"/>
                  </a:cubicBezTo>
                  <a:cubicBezTo>
                    <a:pt x="15478" y="19627"/>
                    <a:pt x="30642" y="22569"/>
                    <a:pt x="40069" y="19427"/>
                  </a:cubicBezTo>
                  <a:cubicBezTo>
                    <a:pt x="49496" y="13142"/>
                    <a:pt x="57053" y="1442"/>
                    <a:pt x="68349" y="573"/>
                  </a:cubicBezTo>
                  <a:cubicBezTo>
                    <a:pt x="99835" y="-1849"/>
                    <a:pt x="131651" y="3807"/>
                    <a:pt x="162617" y="10000"/>
                  </a:cubicBezTo>
                  <a:cubicBezTo>
                    <a:pt x="179210" y="13319"/>
                    <a:pt x="193907" y="22912"/>
                    <a:pt x="209751" y="28853"/>
                  </a:cubicBezTo>
                  <a:cubicBezTo>
                    <a:pt x="219055" y="32342"/>
                    <a:pt x="228605" y="35138"/>
                    <a:pt x="238032" y="38280"/>
                  </a:cubicBezTo>
                  <a:lnTo>
                    <a:pt x="266312" y="123121"/>
                  </a:lnTo>
                  <a:lnTo>
                    <a:pt x="275739" y="151402"/>
                  </a:lnTo>
                  <a:cubicBezTo>
                    <a:pt x="272597" y="220532"/>
                    <a:pt x="273684" y="289984"/>
                    <a:pt x="266312" y="358791"/>
                  </a:cubicBezTo>
                  <a:cubicBezTo>
                    <a:pt x="259680" y="420692"/>
                    <a:pt x="249472" y="401899"/>
                    <a:pt x="228605" y="443633"/>
                  </a:cubicBezTo>
                  <a:cubicBezTo>
                    <a:pt x="217830" y="465184"/>
                    <a:pt x="215130" y="497530"/>
                    <a:pt x="209751" y="519047"/>
                  </a:cubicBezTo>
                  <a:cubicBezTo>
                    <a:pt x="207341" y="528687"/>
                    <a:pt x="203466" y="537901"/>
                    <a:pt x="200324" y="547328"/>
                  </a:cubicBezTo>
                  <a:cubicBezTo>
                    <a:pt x="193101" y="597890"/>
                    <a:pt x="186781" y="649032"/>
                    <a:pt x="172044" y="698156"/>
                  </a:cubicBezTo>
                  <a:cubicBezTo>
                    <a:pt x="163478" y="726709"/>
                    <a:pt x="153191" y="754717"/>
                    <a:pt x="143764" y="782998"/>
                  </a:cubicBezTo>
                  <a:cubicBezTo>
                    <a:pt x="140622" y="792425"/>
                    <a:pt x="134337" y="801341"/>
                    <a:pt x="134337" y="811278"/>
                  </a:cubicBezTo>
                  <a:lnTo>
                    <a:pt x="134337" y="1546569"/>
                  </a:lnTo>
                </a:path>
              </a:pathLst>
            </a:custGeom>
            <a:solidFill>
              <a:schemeClr val="tx1"/>
            </a:solidFill>
            <a:ln w="57150" cap="flat" cmpd="sng" algn="ctr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anchor="ctr"/>
            <a:lstStyle/>
            <a:p>
              <a:endParaRPr lang="en-GB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H="1" flipV="1">
              <a:off x="848" y="1525"/>
              <a:ext cx="17" cy="10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V="1">
              <a:off x="949" y="1586"/>
              <a:ext cx="40" cy="54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flipV="1">
              <a:off x="919" y="1540"/>
              <a:ext cx="22" cy="9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57" name="Group 1045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9" y="1344"/>
              <a:ext cx="227" cy="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tx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8" name="TextBox 75"/>
            <p:cNvSpPr txBox="1">
              <a:spLocks noChangeArrowheads="1"/>
            </p:cNvSpPr>
            <p:nvPr/>
          </p:nvSpPr>
          <p:spPr bwMode="auto">
            <a:xfrm>
              <a:off x="1474" y="1570"/>
              <a:ext cx="186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59" name="TextBox 109"/>
            <p:cNvSpPr txBox="1">
              <a:spLocks noChangeArrowheads="1"/>
            </p:cNvSpPr>
            <p:nvPr/>
          </p:nvSpPr>
          <p:spPr bwMode="auto">
            <a:xfrm>
              <a:off x="1474" y="2614"/>
              <a:ext cx="186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2060" name="Straight Connector 77"/>
            <p:cNvCxnSpPr>
              <a:cxnSpLocks noChangeShapeType="1"/>
            </p:cNvCxnSpPr>
            <p:nvPr/>
          </p:nvCxnSpPr>
          <p:spPr bwMode="auto">
            <a:xfrm flipH="1" flipV="1">
              <a:off x="748" y="845"/>
              <a:ext cx="135" cy="498"/>
            </a:xfrm>
            <a:prstGeom prst="line">
              <a:avLst/>
            </a:prstGeom>
            <a:noFill/>
            <a:ln w="28575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2061" name="TextBox 78"/>
            <p:cNvSpPr txBox="1">
              <a:spLocks noChangeArrowheads="1"/>
            </p:cNvSpPr>
            <p:nvPr/>
          </p:nvSpPr>
          <p:spPr bwMode="auto">
            <a:xfrm>
              <a:off x="476" y="754"/>
              <a:ext cx="626" cy="1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ducer</a:t>
              </a:r>
            </a:p>
          </p:txBody>
        </p:sp>
        <p:pic>
          <p:nvPicPr>
            <p:cNvPr id="206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5733" t="11835" r="27170" b="19743"/>
            <a:stretch>
              <a:fillRect/>
            </a:stretch>
          </p:blipFill>
          <p:spPr bwMode="auto">
            <a:xfrm>
              <a:off x="1655" y="2154"/>
              <a:ext cx="1139" cy="1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3" name="Picture 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9036" t="43314" r="13867" b="11609"/>
            <a:stretch>
              <a:fillRect/>
            </a:stretch>
          </p:blipFill>
          <p:spPr bwMode="auto">
            <a:xfrm>
              <a:off x="2851" y="2154"/>
              <a:ext cx="1139" cy="1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4" name="Picture 9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3785" t="10202" r="34050" b="67267"/>
            <a:stretch>
              <a:fillRect/>
            </a:stretch>
          </p:blipFill>
          <p:spPr bwMode="auto">
            <a:xfrm>
              <a:off x="1662" y="974"/>
              <a:ext cx="1144" cy="1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5" name="Picture 10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0660" t="43317" r="22244" b="23894"/>
            <a:stretch>
              <a:fillRect/>
            </a:stretch>
          </p:blipFill>
          <p:spPr bwMode="auto">
            <a:xfrm>
              <a:off x="2861" y="974"/>
              <a:ext cx="1139" cy="1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6" name="Picture 9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002" t="11211" r="28735" b="30370"/>
            <a:stretch>
              <a:fillRect/>
            </a:stretch>
          </p:blipFill>
          <p:spPr bwMode="auto">
            <a:xfrm>
              <a:off x="4066" y="2154"/>
              <a:ext cx="1179" cy="10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051" name="Straight Arrow Connector 1050"/>
            <p:cNvCxnSpPr/>
            <p:nvPr/>
          </p:nvCxnSpPr>
          <p:spPr bwMode="auto">
            <a:xfrm>
              <a:off x="3444" y="1269"/>
              <a:ext cx="0" cy="220"/>
            </a:xfrm>
            <a:prstGeom prst="straightConnector1">
              <a:avLst/>
            </a:prstGeom>
            <a:ln w="19050">
              <a:solidFill>
                <a:srgbClr val="FFFF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4" name="Straight Arrow Connector 1053"/>
            <p:cNvCxnSpPr/>
            <p:nvPr/>
          </p:nvCxnSpPr>
          <p:spPr bwMode="auto">
            <a:xfrm>
              <a:off x="3249" y="2691"/>
              <a:ext cx="0" cy="0"/>
            </a:xfrm>
            <a:prstGeom prst="straightConnector1">
              <a:avLst/>
            </a:prstGeom>
            <a:ln w="38100"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9" name="TextBox 110"/>
            <p:cNvSpPr txBox="1">
              <a:spLocks noChangeArrowheads="1"/>
            </p:cNvSpPr>
            <p:nvPr/>
          </p:nvSpPr>
          <p:spPr bwMode="auto">
            <a:xfrm>
              <a:off x="4039" y="709"/>
              <a:ext cx="1161" cy="1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or</a:t>
              </a:r>
              <a:r>
                <a:rPr lang="en-GB" alt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ppler </a:t>
              </a:r>
            </a:p>
          </p:txBody>
        </p:sp>
        <p:cxnSp>
          <p:nvCxnSpPr>
            <p:cNvPr id="82" name="Straight Arrow Connector 81"/>
            <p:cNvCxnSpPr/>
            <p:nvPr/>
          </p:nvCxnSpPr>
          <p:spPr bwMode="auto">
            <a:xfrm flipV="1">
              <a:off x="2225" y="1354"/>
              <a:ext cx="1" cy="165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1" name="TextBox 82"/>
            <p:cNvSpPr txBox="1">
              <a:spLocks noChangeArrowheads="1"/>
            </p:cNvSpPr>
            <p:nvPr/>
          </p:nvSpPr>
          <p:spPr bwMode="auto">
            <a:xfrm>
              <a:off x="1791" y="1480"/>
              <a:ext cx="818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tx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 arch</a:t>
              </a:r>
            </a:p>
          </p:txBody>
        </p:sp>
        <p:cxnSp>
          <p:nvCxnSpPr>
            <p:cNvPr id="87" name="Straight Arrow Connector 86"/>
            <p:cNvCxnSpPr/>
            <p:nvPr/>
          </p:nvCxnSpPr>
          <p:spPr bwMode="auto">
            <a:xfrm flipV="1">
              <a:off x="2234" y="2714"/>
              <a:ext cx="4" cy="12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3" name="TextBox 89"/>
            <p:cNvSpPr txBox="1">
              <a:spLocks noChangeArrowheads="1"/>
            </p:cNvSpPr>
            <p:nvPr/>
          </p:nvSpPr>
          <p:spPr bwMode="auto">
            <a:xfrm>
              <a:off x="1771" y="2835"/>
              <a:ext cx="934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 constriction</a:t>
              </a:r>
            </a:p>
          </p:txBody>
        </p:sp>
        <p:cxnSp>
          <p:nvCxnSpPr>
            <p:cNvPr id="92" name="Straight Arrow Connector 91"/>
            <p:cNvCxnSpPr/>
            <p:nvPr/>
          </p:nvCxnSpPr>
          <p:spPr bwMode="auto">
            <a:xfrm>
              <a:off x="3249" y="2691"/>
              <a:ext cx="0" cy="0"/>
            </a:xfrm>
            <a:prstGeom prst="straightConnector1">
              <a:avLst/>
            </a:prstGeom>
            <a:ln>
              <a:solidFill>
                <a:srgbClr val="FFFF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/>
            <p:cNvCxnSpPr/>
            <p:nvPr/>
          </p:nvCxnSpPr>
          <p:spPr bwMode="auto">
            <a:xfrm flipH="1" flipV="1">
              <a:off x="3267" y="2699"/>
              <a:ext cx="73" cy="17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Arrow Connector 102"/>
            <p:cNvCxnSpPr/>
            <p:nvPr/>
          </p:nvCxnSpPr>
          <p:spPr bwMode="auto">
            <a:xfrm flipV="1">
              <a:off x="3440" y="1519"/>
              <a:ext cx="0" cy="129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77" name="Picture 2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2449" t="10564" r="23863" b="37416"/>
            <a:stretch>
              <a:fillRect/>
            </a:stretch>
          </p:blipFill>
          <p:spPr bwMode="auto">
            <a:xfrm>
              <a:off x="4072" y="974"/>
              <a:ext cx="1173" cy="1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78" name="TextBox 82"/>
            <p:cNvSpPr txBox="1">
              <a:spLocks noChangeArrowheads="1"/>
            </p:cNvSpPr>
            <p:nvPr/>
          </p:nvSpPr>
          <p:spPr bwMode="auto">
            <a:xfrm>
              <a:off x="3016" y="1661"/>
              <a:ext cx="819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 arch</a:t>
              </a:r>
            </a:p>
          </p:txBody>
        </p:sp>
        <p:sp>
          <p:nvSpPr>
            <p:cNvPr id="2079" name="TextBox 89"/>
            <p:cNvSpPr txBox="1">
              <a:spLocks noChangeArrowheads="1"/>
            </p:cNvSpPr>
            <p:nvPr/>
          </p:nvSpPr>
          <p:spPr bwMode="auto">
            <a:xfrm>
              <a:off x="2880" y="2886"/>
              <a:ext cx="934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 constriction</a:t>
              </a:r>
            </a:p>
          </p:txBody>
        </p:sp>
        <p:sp>
          <p:nvSpPr>
            <p:cNvPr id="2080" name="TextBox 8"/>
            <p:cNvSpPr txBox="1">
              <a:spLocks noChangeArrowheads="1"/>
            </p:cNvSpPr>
            <p:nvPr/>
          </p:nvSpPr>
          <p:spPr bwMode="auto">
            <a:xfrm>
              <a:off x="3037" y="709"/>
              <a:ext cx="819" cy="1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-Mode</a:t>
              </a:r>
            </a:p>
          </p:txBody>
        </p:sp>
        <p:sp>
          <p:nvSpPr>
            <p:cNvPr id="2081" name="TextBox 51"/>
            <p:cNvSpPr txBox="1">
              <a:spLocks noChangeArrowheads="1"/>
            </p:cNvSpPr>
            <p:nvPr/>
          </p:nvSpPr>
          <p:spPr bwMode="auto">
            <a:xfrm>
              <a:off x="1740" y="709"/>
              <a:ext cx="1049" cy="1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wo-dimensional</a:t>
              </a:r>
            </a:p>
          </p:txBody>
        </p:sp>
        <p:sp>
          <p:nvSpPr>
            <p:cNvPr id="24" name="Freeform 23"/>
            <p:cNvSpPr/>
            <p:nvPr/>
          </p:nvSpPr>
          <p:spPr>
            <a:xfrm>
              <a:off x="839" y="1661"/>
              <a:ext cx="108" cy="126"/>
            </a:xfrm>
            <a:custGeom>
              <a:avLst/>
              <a:gdLst>
                <a:gd name="connsiteX0" fmla="*/ 46701 w 222192"/>
                <a:gd name="connsiteY0" fmla="*/ 92364 h 240145"/>
                <a:gd name="connsiteX1" fmla="*/ 55937 w 222192"/>
                <a:gd name="connsiteY1" fmla="*/ 46182 h 240145"/>
                <a:gd name="connsiteX2" fmla="*/ 65174 w 222192"/>
                <a:gd name="connsiteY2" fmla="*/ 18473 h 240145"/>
                <a:gd name="connsiteX3" fmla="*/ 120592 w 222192"/>
                <a:gd name="connsiteY3" fmla="*/ 0 h 240145"/>
                <a:gd name="connsiteX4" fmla="*/ 166774 w 222192"/>
                <a:gd name="connsiteY4" fmla="*/ 9236 h 240145"/>
                <a:gd name="connsiteX5" fmla="*/ 194483 w 222192"/>
                <a:gd name="connsiteY5" fmla="*/ 64655 h 240145"/>
                <a:gd name="connsiteX6" fmla="*/ 222192 w 222192"/>
                <a:gd name="connsiteY6" fmla="*/ 120073 h 240145"/>
                <a:gd name="connsiteX7" fmla="*/ 212955 w 222192"/>
                <a:gd name="connsiteY7" fmla="*/ 221673 h 240145"/>
                <a:gd name="connsiteX8" fmla="*/ 185246 w 222192"/>
                <a:gd name="connsiteY8" fmla="*/ 230909 h 240145"/>
                <a:gd name="connsiteX9" fmla="*/ 111355 w 222192"/>
                <a:gd name="connsiteY9" fmla="*/ 240145 h 240145"/>
                <a:gd name="connsiteX10" fmla="*/ 46701 w 222192"/>
                <a:gd name="connsiteY10" fmla="*/ 193964 h 240145"/>
                <a:gd name="connsiteX11" fmla="*/ 9755 w 222192"/>
                <a:gd name="connsiteY11" fmla="*/ 138545 h 240145"/>
                <a:gd name="connsiteX12" fmla="*/ 9755 w 222192"/>
                <a:gd name="connsiteY12" fmla="*/ 83127 h 240145"/>
                <a:gd name="connsiteX13" fmla="*/ 37464 w 222192"/>
                <a:gd name="connsiteY13" fmla="*/ 73891 h 240145"/>
                <a:gd name="connsiteX14" fmla="*/ 65174 w 222192"/>
                <a:gd name="connsiteY14" fmla="*/ 36945 h 2401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222192" h="240145">
                  <a:moveTo>
                    <a:pt x="46701" y="92364"/>
                  </a:moveTo>
                  <a:cubicBezTo>
                    <a:pt x="49780" y="76970"/>
                    <a:pt x="52129" y="61412"/>
                    <a:pt x="55937" y="46182"/>
                  </a:cubicBezTo>
                  <a:cubicBezTo>
                    <a:pt x="58298" y="36737"/>
                    <a:pt x="57251" y="24132"/>
                    <a:pt x="65174" y="18473"/>
                  </a:cubicBezTo>
                  <a:cubicBezTo>
                    <a:pt x="81019" y="7155"/>
                    <a:pt x="120592" y="0"/>
                    <a:pt x="120592" y="0"/>
                  </a:cubicBezTo>
                  <a:cubicBezTo>
                    <a:pt x="135986" y="3079"/>
                    <a:pt x="153144" y="1447"/>
                    <a:pt x="166774" y="9236"/>
                  </a:cubicBezTo>
                  <a:cubicBezTo>
                    <a:pt x="185301" y="19823"/>
                    <a:pt x="186425" y="48538"/>
                    <a:pt x="194483" y="64655"/>
                  </a:cubicBezTo>
                  <a:cubicBezTo>
                    <a:pt x="230294" y="136279"/>
                    <a:pt x="198973" y="50422"/>
                    <a:pt x="222192" y="120073"/>
                  </a:cubicBezTo>
                  <a:cubicBezTo>
                    <a:pt x="219113" y="153940"/>
                    <a:pt x="223709" y="189412"/>
                    <a:pt x="212955" y="221673"/>
                  </a:cubicBezTo>
                  <a:cubicBezTo>
                    <a:pt x="209876" y="230909"/>
                    <a:pt x="194825" y="229167"/>
                    <a:pt x="185246" y="230909"/>
                  </a:cubicBezTo>
                  <a:cubicBezTo>
                    <a:pt x="160824" y="235349"/>
                    <a:pt x="135985" y="237066"/>
                    <a:pt x="111355" y="240145"/>
                  </a:cubicBezTo>
                  <a:cubicBezTo>
                    <a:pt x="21510" y="210198"/>
                    <a:pt x="74690" y="244344"/>
                    <a:pt x="46701" y="193964"/>
                  </a:cubicBezTo>
                  <a:cubicBezTo>
                    <a:pt x="35919" y="174556"/>
                    <a:pt x="9755" y="138545"/>
                    <a:pt x="9755" y="138545"/>
                  </a:cubicBezTo>
                  <a:cubicBezTo>
                    <a:pt x="3598" y="120073"/>
                    <a:pt x="-8717" y="101599"/>
                    <a:pt x="9755" y="83127"/>
                  </a:cubicBezTo>
                  <a:cubicBezTo>
                    <a:pt x="16639" y="76243"/>
                    <a:pt x="28228" y="76970"/>
                    <a:pt x="37464" y="73891"/>
                  </a:cubicBezTo>
                  <a:cubicBezTo>
                    <a:pt x="58352" y="42559"/>
                    <a:pt x="48088" y="54031"/>
                    <a:pt x="65174" y="36945"/>
                  </a:cubicBezTo>
                </a:path>
              </a:pathLst>
            </a:cu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</TotalTime>
  <Words>57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Manchest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 Zi</dc:creator>
  <cp:lastModifiedBy>min</cp:lastModifiedBy>
  <cp:revision>41</cp:revision>
  <dcterms:created xsi:type="dcterms:W3CDTF">2014-05-29T10:35:50Z</dcterms:created>
  <dcterms:modified xsi:type="dcterms:W3CDTF">2019-10-20T14:03:58Z</dcterms:modified>
</cp:coreProperties>
</file>